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63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235A8747-CFCB-4526-9FAE-E660A7B54F1D}">
          <p14:sldIdLst>
            <p14:sldId id="257"/>
            <p14:sldId id="263"/>
            <p14:sldId id="259"/>
            <p14:sldId id="260"/>
            <p14:sldId id="261"/>
            <p14:sldId id="26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BC4776-6032-44B0-ADF3-D226B595C8DA}" v="38" dt="2023-06-08T13:58:36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7" d="100"/>
          <a:sy n="67" d="100"/>
        </p:scale>
        <p:origin x="45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studentsrwthaachende-my.sharepoint.com/personal/npmj69ndfjpdbf95_students_rwth-aachen_de/Documents/9.%20Semester%20(Doktorarbeit)/Ver&#246;ffentlichungsprozess/relative%20Ergebnisse%20+%20Grafiken_Version%20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studentsrwthaachende-my.sharepoint.com/personal/npmj69ndfjpdbf95_students_rwth-aachen_de/Documents/9.%20Semester%20(Doktorarbeit)/Ver&#246;ffentlichungsprozess/relative%20Ergebnisse%20+%20Grafiken_Version%20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studentsrwthaachende-my.sharepoint.com/personal/npmj69ndfjpdbf95_students_rwth-aachen_de/Documents/9.%20Semester%20(Doktorarbeit)/Ver&#246;ffentlichungsprozess/relative%20Ergebnisse%20+%20Grafiken_Version%20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klinikum\org\HGEN\humangenetik\Forschung\Eggermann\Mitarbeiter\Elia%20Schlaich\Imprinting-Mosaike\relative%20Ergebnisse%20+%20Grafike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klinikum\org\HGEN\humangenetik\Forschung\Eggermann\Mitarbeiter\Elia%20Schlaich\Imprinting-Mosaike\relative%20Ergebnisse%20+%20Grafiken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klinikum\org\HGEN\humangenetik\Forschung\Eggermann\Mitarbeiter\Elia%20Schlaich\Papererstellung\relative%20Ergebnisse%20+%20Grafiken_NEU.xlsx%20-%20Verkn&#252;pfung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3"/>
          <c:order val="0"/>
          <c:tx>
            <c:v>4th BSC</c:v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B$39:$AD$39</c:f>
              <c:strCache>
                <c:ptCount val="8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  <c:pt idx="7">
                  <c:v>Run 8</c:v>
                </c:pt>
              </c:strCache>
              <c:extLst/>
            </c:strRef>
          </c:cat>
          <c:val>
            <c:numRef>
              <c:f>'[relative Ergebnisse + Grafiken_Version 5.xlsx]ddPCR'!$E$42:$AG$42</c:f>
              <c:numCache>
                <c:formatCode>General</c:formatCode>
                <c:ptCount val="8"/>
                <c:pt idx="5" formatCode="0.0000">
                  <c:v>1.3553527487486887E-2</c:v>
                </c:pt>
                <c:pt idx="7" formatCode="0.0000">
                  <c:v>8.4550847097786992E-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756C-4D92-B6E5-F1C81B38AD98}"/>
            </c:ext>
          </c:extLst>
        </c:ser>
        <c:ser>
          <c:idx val="2"/>
          <c:order val="1"/>
          <c:tx>
            <c:v>3rd BSC</c:v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B$39:$AD$39</c:f>
              <c:strCache>
                <c:ptCount val="8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  <c:pt idx="7">
                  <c:v>Run 8</c:v>
                </c:pt>
              </c:strCache>
              <c:extLst/>
            </c:strRef>
          </c:cat>
          <c:val>
            <c:numRef>
              <c:f>'[relative Ergebnisse + Grafiken_Version 5.xlsx]ddPCR'!$E$41:$AG$41</c:f>
              <c:numCache>
                <c:formatCode>General</c:formatCode>
                <c:ptCount val="8"/>
                <c:pt idx="3" formatCode="0.0000">
                  <c:v>1.2125727077339195E-2</c:v>
                </c:pt>
                <c:pt idx="4" formatCode="0.0000">
                  <c:v>7.9795999632913325E-3</c:v>
                </c:pt>
                <c:pt idx="6" formatCode="0.0000">
                  <c:v>2.3067019735780288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756C-4D92-B6E5-F1C81B38AD98}"/>
            </c:ext>
          </c:extLst>
        </c:ser>
        <c:ser>
          <c:idx val="1"/>
          <c:order val="2"/>
          <c:tx>
            <c:v>2nd BSC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B$39:$AD$39</c:f>
              <c:strCache>
                <c:ptCount val="8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  <c:pt idx="7">
                  <c:v>Run 8</c:v>
                </c:pt>
              </c:strCache>
              <c:extLst/>
            </c:strRef>
          </c:cat>
          <c:val>
            <c:numRef>
              <c:f>'[relative Ergebnisse + Grafiken_Version 5.xlsx]ddPCR'!$E$40:$AG$40</c:f>
              <c:numCache>
                <c:formatCode>0.0000</c:formatCode>
                <c:ptCount val="8"/>
                <c:pt idx="0">
                  <c:v>1.7996125477390046E-2</c:v>
                </c:pt>
                <c:pt idx="1">
                  <c:v>2.0048887879891911E-2</c:v>
                </c:pt>
                <c:pt idx="2">
                  <c:v>2.1701971501269131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756C-4D92-B6E5-F1C81B38AD98}"/>
            </c:ext>
          </c:extLst>
        </c:ser>
        <c:ser>
          <c:idx val="0"/>
          <c:order val="3"/>
          <c:tx>
            <c:v>1st BSC</c:v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B$39:$AD$39</c:f>
              <c:strCache>
                <c:ptCount val="8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  <c:pt idx="7">
                  <c:v>Run 8</c:v>
                </c:pt>
              </c:strCache>
              <c:extLst/>
            </c:strRef>
          </c:cat>
          <c:val>
            <c:numRef>
              <c:f>'[relative Ergebnisse + Grafiken_Version 5.xlsx]ddPCR'!$E$39:$AG$39</c:f>
              <c:numCache>
                <c:formatCode>0.0000</c:formatCode>
                <c:ptCount val="8"/>
                <c:pt idx="0">
                  <c:v>1.8068479260351704E-2</c:v>
                </c:pt>
                <c:pt idx="1">
                  <c:v>8.5340671792370117E-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756C-4D92-B6E5-F1C81B38AD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8453992"/>
        <c:axId val="488462192"/>
      </c:barChart>
      <c:catAx>
        <c:axId val="488453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88462192"/>
        <c:crosses val="autoZero"/>
        <c:auto val="0"/>
        <c:lblAlgn val="ctr"/>
        <c:lblOffset val="100"/>
        <c:noMultiLvlLbl val="0"/>
      </c:catAx>
      <c:valAx>
        <c:axId val="4884621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88453992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50000"/>
                  <a:lumOff val="5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zero"/>
    <c:showDLblsOverMax val="0"/>
  </c:chart>
  <c:spPr>
    <a:gradFill flip="none" rotWithShape="1">
      <a:gsLst>
        <a:gs pos="100000">
          <a:schemeClr val="lt1">
            <a:lumMod val="95000"/>
          </a:schemeClr>
        </a:gs>
        <a:gs pos="43000">
          <a:schemeClr val="lt1"/>
        </a:gs>
      </a:gsLst>
      <a:path path="circle">
        <a:fillToRect l="50000" t="50000" r="50000" b="50000"/>
      </a:path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3"/>
          <c:order val="0"/>
          <c:tx>
            <c:v>4th BSC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AJ$39:$BH$39</c:f>
              <c:strCache>
                <c:ptCount val="7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</c:strCache>
              <c:extLst/>
            </c:strRef>
          </c:cat>
          <c:val>
            <c:numRef>
              <c:f>'[relative Ergebnisse + Grafiken_Version 5.xlsx]ddPCR'!$AM$42:$BK$42</c:f>
              <c:numCache>
                <c:formatCode>General</c:formatCode>
                <c:ptCount val="7"/>
                <c:pt idx="5" formatCode="0.0000">
                  <c:v>3.2709361169405891E-2</c:v>
                </c:pt>
                <c:pt idx="6" formatCode="0.0000">
                  <c:v>1.8526507661406854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F641-4AA9-B532-3FD5A5633BF8}"/>
            </c:ext>
          </c:extLst>
        </c:ser>
        <c:ser>
          <c:idx val="2"/>
          <c:order val="1"/>
          <c:tx>
            <c:v>3rd BSC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AJ$39:$BH$39</c:f>
              <c:strCache>
                <c:ptCount val="7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</c:strCache>
              <c:extLst/>
            </c:strRef>
          </c:cat>
          <c:val>
            <c:numRef>
              <c:f>'[relative Ergebnisse + Grafiken_Version 5.xlsx]ddPCR'!$AM$41:$BK$41</c:f>
              <c:numCache>
                <c:formatCode>General</c:formatCode>
                <c:ptCount val="7"/>
                <c:pt idx="3" formatCode="0.0000">
                  <c:v>4.4228729925819714E-2</c:v>
                </c:pt>
                <c:pt idx="4" formatCode="0.0000">
                  <c:v>5.372914333714341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F641-4AA9-B532-3FD5A5633BF8}"/>
            </c:ext>
          </c:extLst>
        </c:ser>
        <c:ser>
          <c:idx val="1"/>
          <c:order val="2"/>
          <c:tx>
            <c:v>2nd BSC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AJ$39:$BH$39</c:f>
              <c:strCache>
                <c:ptCount val="7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</c:strCache>
              <c:extLst/>
            </c:strRef>
          </c:cat>
          <c:val>
            <c:numRef>
              <c:f>'[relative Ergebnisse + Grafiken_Version 5.xlsx]ddPCR'!$AM$40:$BK$40</c:f>
              <c:numCache>
                <c:formatCode>0.0000</c:formatCode>
                <c:ptCount val="7"/>
                <c:pt idx="0">
                  <c:v>9.6496164788380887E-3</c:v>
                </c:pt>
                <c:pt idx="1">
                  <c:v>2.3064509130403414E-2</c:v>
                </c:pt>
                <c:pt idx="2">
                  <c:v>2.2421032660105023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F641-4AA9-B532-3FD5A5633BF8}"/>
            </c:ext>
          </c:extLst>
        </c:ser>
        <c:ser>
          <c:idx val="0"/>
          <c:order val="3"/>
          <c:tx>
            <c:v>1st BSC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relative Ergebnisse + Grafiken_Version 5.xlsx]ddPCR'!$AJ$39:$BH$39</c:f>
              <c:strCache>
                <c:ptCount val="7"/>
                <c:pt idx="0">
                  <c:v>Run 1</c:v>
                </c:pt>
                <c:pt idx="1">
                  <c:v>Run 2</c:v>
                </c:pt>
                <c:pt idx="2">
                  <c:v>Run 3</c:v>
                </c:pt>
                <c:pt idx="3">
                  <c:v>Run 4</c:v>
                </c:pt>
                <c:pt idx="4">
                  <c:v>Run 5</c:v>
                </c:pt>
                <c:pt idx="5">
                  <c:v>Run 6</c:v>
                </c:pt>
                <c:pt idx="6">
                  <c:v>Run 7</c:v>
                </c:pt>
              </c:strCache>
              <c:extLst/>
            </c:strRef>
          </c:cat>
          <c:val>
            <c:numRef>
              <c:f>'[relative Ergebnisse + Grafiken_Version 5.xlsx]ddPCR'!$AM$39:$BK$39</c:f>
              <c:numCache>
                <c:formatCode>0.0000</c:formatCode>
                <c:ptCount val="7"/>
                <c:pt idx="0">
                  <c:v>1.5515924193089487E-2</c:v>
                </c:pt>
                <c:pt idx="1">
                  <c:v>2.6662200065543359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F641-4AA9-B532-3FD5A5633B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8453992"/>
        <c:axId val="488462192"/>
      </c:barChart>
      <c:catAx>
        <c:axId val="488453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88462192"/>
        <c:crosses val="autoZero"/>
        <c:auto val="0"/>
        <c:lblAlgn val="ctr"/>
        <c:lblOffset val="100"/>
        <c:noMultiLvlLbl val="0"/>
      </c:catAx>
      <c:valAx>
        <c:axId val="4884621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88453992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50000"/>
                  <a:lumOff val="5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gradFill flip="none" rotWithShape="1">
      <a:gsLst>
        <a:gs pos="100000">
          <a:schemeClr val="lt1">
            <a:lumMod val="95000"/>
          </a:schemeClr>
        </a:gs>
        <a:gs pos="43000">
          <a:schemeClr val="lt1"/>
        </a:gs>
      </a:gsLst>
      <a:path path="circle">
        <a:fillToRect l="50000" t="50000" r="50000" b="50000"/>
      </a:path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IC1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[relative Ergebnisse + Grafiken_Version 5.xlsx]ddPCR'!$AI$59:$AI$74</c:f>
              <c:strCache>
                <c:ptCount val="16"/>
                <c:pt idx="0">
                  <c:v>Control A BSC 1</c:v>
                </c:pt>
                <c:pt idx="1">
                  <c:v>Control A BSC 3</c:v>
                </c:pt>
                <c:pt idx="2">
                  <c:v>Control A BSC 4</c:v>
                </c:pt>
                <c:pt idx="3">
                  <c:v>Control B BSC 1</c:v>
                </c:pt>
                <c:pt idx="4">
                  <c:v>Control B BSC 3</c:v>
                </c:pt>
                <c:pt idx="5">
                  <c:v>Control B BSC 4</c:v>
                </c:pt>
                <c:pt idx="6">
                  <c:v>Control C BSC 1</c:v>
                </c:pt>
                <c:pt idx="7">
                  <c:v>Control C BSC 3</c:v>
                </c:pt>
                <c:pt idx="8">
                  <c:v>Control C BSC 4</c:v>
                </c:pt>
                <c:pt idx="9">
                  <c:v>Control D BSC 1</c:v>
                </c:pt>
                <c:pt idx="10">
                  <c:v>Control D BSC 3</c:v>
                </c:pt>
                <c:pt idx="11">
                  <c:v>Control D BSC 4</c:v>
                </c:pt>
                <c:pt idx="12">
                  <c:v>M24412 BSC 1</c:v>
                </c:pt>
                <c:pt idx="13">
                  <c:v>M24412 BSC 2</c:v>
                </c:pt>
                <c:pt idx="14">
                  <c:v>M31540 BSC 1</c:v>
                </c:pt>
                <c:pt idx="15">
                  <c:v>M31540 BSC 2</c:v>
                </c:pt>
              </c:strCache>
            </c:strRef>
          </c:cat>
          <c:val>
            <c:numRef>
              <c:f>'[relative Ergebnisse + Grafiken_Version 5.xlsx]ddPCR'!$C$59:$C$74</c:f>
              <c:numCache>
                <c:formatCode>0.000</c:formatCode>
                <c:ptCount val="16"/>
                <c:pt idx="0">
                  <c:v>1.3092719879176064E-2</c:v>
                </c:pt>
                <c:pt idx="1">
                  <c:v>1.8765475537726853E-2</c:v>
                </c:pt>
                <c:pt idx="2">
                  <c:v>7.6968282488509105E-4</c:v>
                </c:pt>
                <c:pt idx="3">
                  <c:v>1.7073176267610856E-2</c:v>
                </c:pt>
                <c:pt idx="4">
                  <c:v>1.1675297745708807E-2</c:v>
                </c:pt>
                <c:pt idx="5">
                  <c:v>4.3218520773574184E-3</c:v>
                </c:pt>
                <c:pt idx="6">
                  <c:v>1.7384335832968462E-2</c:v>
                </c:pt>
                <c:pt idx="7">
                  <c:v>1.9360048671277903E-2</c:v>
                </c:pt>
                <c:pt idx="8">
                  <c:v>1.8160559326197114E-2</c:v>
                </c:pt>
                <c:pt idx="9">
                  <c:v>9.9268048656052741E-3</c:v>
                </c:pt>
                <c:pt idx="10">
                  <c:v>1.1076462640885298E-2</c:v>
                </c:pt>
                <c:pt idx="11">
                  <c:v>6.4882231028893468E-3</c:v>
                </c:pt>
                <c:pt idx="12">
                  <c:v>3.1904743751633574E-2</c:v>
                </c:pt>
                <c:pt idx="13">
                  <c:v>1.792956265241832E-2</c:v>
                </c:pt>
                <c:pt idx="14">
                  <c:v>3.677788013338608E-3</c:v>
                </c:pt>
                <c:pt idx="15">
                  <c:v>9.145393552438606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11-470D-8C5E-D5CA4148B43E}"/>
            </c:ext>
          </c:extLst>
        </c:ser>
        <c:ser>
          <c:idx val="1"/>
          <c:order val="1"/>
          <c:tx>
            <c:v>IC2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[relative Ergebnisse + Grafiken_Version 5.xlsx]ddPCR'!$AI$59:$AI$74</c:f>
              <c:strCache>
                <c:ptCount val="16"/>
                <c:pt idx="0">
                  <c:v>Control A BSC 1</c:v>
                </c:pt>
                <c:pt idx="1">
                  <c:v>Control A BSC 3</c:v>
                </c:pt>
                <c:pt idx="2">
                  <c:v>Control A BSC 4</c:v>
                </c:pt>
                <c:pt idx="3">
                  <c:v>Control B BSC 1</c:v>
                </c:pt>
                <c:pt idx="4">
                  <c:v>Control B BSC 3</c:v>
                </c:pt>
                <c:pt idx="5">
                  <c:v>Control B BSC 4</c:v>
                </c:pt>
                <c:pt idx="6">
                  <c:v>Control C BSC 1</c:v>
                </c:pt>
                <c:pt idx="7">
                  <c:v>Control C BSC 3</c:v>
                </c:pt>
                <c:pt idx="8">
                  <c:v>Control C BSC 4</c:v>
                </c:pt>
                <c:pt idx="9">
                  <c:v>Control D BSC 1</c:v>
                </c:pt>
                <c:pt idx="10">
                  <c:v>Control D BSC 3</c:v>
                </c:pt>
                <c:pt idx="11">
                  <c:v>Control D BSC 4</c:v>
                </c:pt>
                <c:pt idx="12">
                  <c:v>M24412 BSC 1</c:v>
                </c:pt>
                <c:pt idx="13">
                  <c:v>M24412 BSC 2</c:v>
                </c:pt>
                <c:pt idx="14">
                  <c:v>M31540 BSC 1</c:v>
                </c:pt>
                <c:pt idx="15">
                  <c:v>M31540 BSC 2</c:v>
                </c:pt>
              </c:strCache>
            </c:strRef>
          </c:cat>
          <c:val>
            <c:numRef>
              <c:f>'[relative Ergebnisse + Grafiken_Version 5.xlsx]ddPCR'!$AK$59:$AK$74</c:f>
              <c:numCache>
                <c:formatCode>0.000</c:formatCode>
                <c:ptCount val="16"/>
                <c:pt idx="0">
                  <c:v>2.6121096161094585E-2</c:v>
                </c:pt>
                <c:pt idx="1">
                  <c:v>1.9723370498488945E-2</c:v>
                </c:pt>
                <c:pt idx="2">
                  <c:v>3.6264482615700921E-2</c:v>
                </c:pt>
                <c:pt idx="3">
                  <c:v>5.6135372384180995E-4</c:v>
                </c:pt>
                <c:pt idx="4">
                  <c:v>1.7351171696997104E-2</c:v>
                </c:pt>
                <c:pt idx="5">
                  <c:v>1.9057368098853708E-2</c:v>
                </c:pt>
                <c:pt idx="6">
                  <c:v>4.5792075946764089E-3</c:v>
                </c:pt>
                <c:pt idx="7">
                  <c:v>4.246785337268337E-2</c:v>
                </c:pt>
                <c:pt idx="8">
                  <c:v>3.507243041213897E-2</c:v>
                </c:pt>
                <c:pt idx="9">
                  <c:v>1.0897695629241597E-2</c:v>
                </c:pt>
                <c:pt idx="10">
                  <c:v>2.706779271053106E-3</c:v>
                </c:pt>
                <c:pt idx="11">
                  <c:v>2.4560240498063962E-2</c:v>
                </c:pt>
                <c:pt idx="12">
                  <c:v>3.0797473310429851E-2</c:v>
                </c:pt>
                <c:pt idx="13">
                  <c:v>1.2240479596966558E-2</c:v>
                </c:pt>
                <c:pt idx="14">
                  <c:v>1.6219601831443844E-2</c:v>
                </c:pt>
                <c:pt idx="15">
                  <c:v>7.7775606823989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11-470D-8C5E-D5CA4148B43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444"/>
        <c:overlap val="-90"/>
        <c:axId val="452764656"/>
        <c:axId val="452769248"/>
      </c:barChart>
      <c:catAx>
        <c:axId val="452764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2769248"/>
        <c:crosses val="autoZero"/>
        <c:auto val="1"/>
        <c:lblAlgn val="ctr"/>
        <c:lblOffset val="100"/>
        <c:noMultiLvlLbl val="0"/>
      </c:catAx>
      <c:valAx>
        <c:axId val="452769248"/>
        <c:scaling>
          <c:orientation val="minMax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S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.000" sourceLinked="1"/>
        <c:majorTickMark val="none"/>
        <c:minorTickMark val="none"/>
        <c:tickLblPos val="nextTo"/>
        <c:crossAx val="452764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7449450128568568"/>
          <c:y val="4.2459095334857339E-3"/>
          <c:w val="0.25101071741032371"/>
          <c:h val="7.8125546806649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Run 1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A$12:$A$30</c:f>
              <c:strCache>
                <c:ptCount val="19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  <c:pt idx="17">
                  <c:v>M26087 1.BSC</c:v>
                </c:pt>
                <c:pt idx="18">
                  <c:v>M22681 1.BSC</c:v>
                </c:pt>
              </c:strCache>
            </c:strRef>
          </c:xVal>
          <c:yVal>
            <c:numRef>
              <c:f>Pyrosequencing!$C$12:$C$18</c:f>
              <c:numCache>
                <c:formatCode>#,##0.00</c:formatCode>
                <c:ptCount val="7"/>
                <c:pt idx="0">
                  <c:v>3.0400315519621377</c:v>
                </c:pt>
                <c:pt idx="1">
                  <c:v>3.1354762374285152</c:v>
                </c:pt>
                <c:pt idx="2">
                  <c:v>2.8519029777164269</c:v>
                </c:pt>
                <c:pt idx="3">
                  <c:v>1.2715440741471111</c:v>
                </c:pt>
                <c:pt idx="4">
                  <c:v>3.2699664760402287</c:v>
                </c:pt>
                <c:pt idx="5">
                  <c:v>2.4638138434233876</c:v>
                </c:pt>
                <c:pt idx="6">
                  <c:v>1.60599487280615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E2-448B-B0DD-3C00404D00E3}"/>
            </c:ext>
          </c:extLst>
        </c:ser>
        <c:ser>
          <c:idx val="5"/>
          <c:order val="1"/>
          <c:tx>
            <c:v>Run 2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A$12:$A$30</c:f>
              <c:strCache>
                <c:ptCount val="19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  <c:pt idx="17">
                  <c:v>M26087 1.BSC</c:v>
                </c:pt>
                <c:pt idx="18">
                  <c:v>M22681 1.BSC</c:v>
                </c:pt>
              </c:strCache>
            </c:strRef>
          </c:xVal>
          <c:yVal>
            <c:numRef>
              <c:f>Pyrosequencing!$E$12:$E$30</c:f>
              <c:numCache>
                <c:formatCode>#,##0.00</c:formatCode>
                <c:ptCount val="19"/>
                <c:pt idx="0">
                  <c:v>2.0533209475150951</c:v>
                </c:pt>
                <c:pt idx="1">
                  <c:v>3.0509986065954484</c:v>
                </c:pt>
                <c:pt idx="17">
                  <c:v>0.33887598699489085</c:v>
                </c:pt>
                <c:pt idx="18">
                  <c:v>0.33218764514630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DE2-448B-B0DD-3C00404D00E3}"/>
            </c:ext>
          </c:extLst>
        </c:ser>
        <c:ser>
          <c:idx val="8"/>
          <c:order val="2"/>
          <c:tx>
            <c:v>Run 3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A$12:$A$30</c:f>
              <c:strCache>
                <c:ptCount val="19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  <c:pt idx="17">
                  <c:v>M26087 1.BSC</c:v>
                </c:pt>
                <c:pt idx="18">
                  <c:v>M22681 1.BSC</c:v>
                </c:pt>
              </c:strCache>
            </c:strRef>
          </c:xVal>
          <c:yVal>
            <c:numRef>
              <c:f>Pyrosequencing!$G$12:$G$30</c:f>
              <c:numCache>
                <c:formatCode>#,##0.00</c:formatCode>
                <c:ptCount val="19"/>
                <c:pt idx="0">
                  <c:v>1.9030303030303026</c:v>
                </c:pt>
                <c:pt idx="1">
                  <c:v>2.3934731934731932</c:v>
                </c:pt>
                <c:pt idx="2">
                  <c:v>1.8874902874902872</c:v>
                </c:pt>
                <c:pt idx="3">
                  <c:v>1.8483294483294481</c:v>
                </c:pt>
                <c:pt idx="4">
                  <c:v>2.0273504273504273</c:v>
                </c:pt>
                <c:pt idx="5">
                  <c:v>2.1843045843045839</c:v>
                </c:pt>
                <c:pt idx="6">
                  <c:v>1.7961149961149958</c:v>
                </c:pt>
                <c:pt idx="7">
                  <c:v>2.7595959595959596</c:v>
                </c:pt>
                <c:pt idx="8">
                  <c:v>2.084537684537684</c:v>
                </c:pt>
                <c:pt idx="9">
                  <c:v>1.8234654234654233</c:v>
                </c:pt>
                <c:pt idx="10">
                  <c:v>2.2675990675990669</c:v>
                </c:pt>
                <c:pt idx="11">
                  <c:v>1.4766122766122765</c:v>
                </c:pt>
                <c:pt idx="12">
                  <c:v>1.386169386169386</c:v>
                </c:pt>
                <c:pt idx="13">
                  <c:v>1.6074592074592071</c:v>
                </c:pt>
                <c:pt idx="14">
                  <c:v>2.1252525252525247</c:v>
                </c:pt>
                <c:pt idx="15">
                  <c:v>1.4160062160062159</c:v>
                </c:pt>
                <c:pt idx="16">
                  <c:v>2.502253302253302</c:v>
                </c:pt>
                <c:pt idx="17">
                  <c:v>0.350271950271950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DE2-448B-B0DD-3C00404D00E3}"/>
            </c:ext>
          </c:extLst>
        </c:ser>
        <c:ser>
          <c:idx val="11"/>
          <c:order val="3"/>
          <c:tx>
            <c:v>Run 4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A$12:$A$30</c:f>
              <c:strCache>
                <c:ptCount val="19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  <c:pt idx="17">
                  <c:v>M26087 1.BSC</c:v>
                </c:pt>
                <c:pt idx="18">
                  <c:v>M22681 1.BSC</c:v>
                </c:pt>
              </c:strCache>
            </c:strRef>
          </c:xVal>
          <c:yVal>
            <c:numRef>
              <c:f>Pyrosequencing!$I$12:$I$30</c:f>
              <c:numCache>
                <c:formatCode>#,##0.00</c:formatCode>
                <c:ptCount val="19"/>
                <c:pt idx="0">
                  <c:v>1.0881767798777886</c:v>
                </c:pt>
                <c:pt idx="1">
                  <c:v>1.7642461276111976</c:v>
                </c:pt>
                <c:pt idx="2">
                  <c:v>1.6736535455449764</c:v>
                </c:pt>
                <c:pt idx="3">
                  <c:v>1.498507886883615</c:v>
                </c:pt>
                <c:pt idx="4">
                  <c:v>1.5617450618161146</c:v>
                </c:pt>
                <c:pt idx="5">
                  <c:v>1.1961773483018332</c:v>
                </c:pt>
                <c:pt idx="6">
                  <c:v>1.0046894983657808</c:v>
                </c:pt>
                <c:pt idx="7">
                  <c:v>1.5876794088389936</c:v>
                </c:pt>
                <c:pt idx="8">
                  <c:v>1.2157169248259199</c:v>
                </c:pt>
                <c:pt idx="9">
                  <c:v>1.17344038652835</c:v>
                </c:pt>
                <c:pt idx="10">
                  <c:v>1.2647434986499928</c:v>
                </c:pt>
                <c:pt idx="11">
                  <c:v>1.177703566860878</c:v>
                </c:pt>
                <c:pt idx="12">
                  <c:v>1.3059542418644305</c:v>
                </c:pt>
                <c:pt idx="13">
                  <c:v>1.1144663919283784</c:v>
                </c:pt>
                <c:pt idx="14">
                  <c:v>1.5624555918715359</c:v>
                </c:pt>
                <c:pt idx="15">
                  <c:v>0.33927810146369192</c:v>
                </c:pt>
                <c:pt idx="16">
                  <c:v>1.2132300696319454</c:v>
                </c:pt>
                <c:pt idx="17">
                  <c:v>0.199658945573397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DE2-448B-B0DD-3C00404D00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2829872"/>
        <c:axId val="312832496"/>
      </c:scatterChart>
      <c:valAx>
        <c:axId val="312829872"/>
        <c:scaling>
          <c:orientation val="minMax"/>
          <c:max val="19.399999999999999"/>
          <c:min val="0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32496"/>
        <c:crosses val="autoZero"/>
        <c:crossBetween val="midCat"/>
        <c:majorUnit val="1"/>
        <c:minorUnit val="1"/>
      </c:valAx>
      <c:valAx>
        <c:axId val="312832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latin typeface="Arial" panose="020B0604020202020204" pitchFamily="34" charset="0"/>
                    <a:cs typeface="Arial" panose="020B0604020202020204" pitchFamily="34" charset="0"/>
                  </a:rPr>
                  <a:t>Control-adjusted Methylation val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298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100000">
          <a:schemeClr val="lt1">
            <a:lumMod val="95000"/>
          </a:schemeClr>
        </a:gs>
        <a:gs pos="43000">
          <a:schemeClr val="lt1"/>
        </a:gs>
      </a:gsLst>
      <a:path path="circle">
        <a:fillToRect l="50000" t="50000" r="50000" b="50000"/>
      </a:path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Run 1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J$12:$J$2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Pyrosequencing!$L$12:$L$28</c:f>
              <c:numCache>
                <c:formatCode>#,##0.00</c:formatCode>
                <c:ptCount val="17"/>
                <c:pt idx="0">
                  <c:v>0.43471189591078069</c:v>
                </c:pt>
                <c:pt idx="1">
                  <c:v>0.5420539033457249</c:v>
                </c:pt>
                <c:pt idx="2">
                  <c:v>0.58317843866171004</c:v>
                </c:pt>
                <c:pt idx="3">
                  <c:v>0.4528345724907063</c:v>
                </c:pt>
                <c:pt idx="4">
                  <c:v>0.43935873605947956</c:v>
                </c:pt>
                <c:pt idx="5">
                  <c:v>0.37778810408921937</c:v>
                </c:pt>
                <c:pt idx="6">
                  <c:v>0.47932156133828996</c:v>
                </c:pt>
                <c:pt idx="7">
                  <c:v>0.40195167286245354</c:v>
                </c:pt>
                <c:pt idx="8">
                  <c:v>0.46956319702602234</c:v>
                </c:pt>
                <c:pt idx="9">
                  <c:v>0.35664498141263939</c:v>
                </c:pt>
                <c:pt idx="10">
                  <c:v>0.29948884758364314</c:v>
                </c:pt>
                <c:pt idx="11">
                  <c:v>0.59061338289962828</c:v>
                </c:pt>
                <c:pt idx="12">
                  <c:v>0.30901486988847587</c:v>
                </c:pt>
                <c:pt idx="13">
                  <c:v>0.58480483271375472</c:v>
                </c:pt>
                <c:pt idx="14">
                  <c:v>0.41473048327137552</c:v>
                </c:pt>
                <c:pt idx="15">
                  <c:v>0.3852230483271375</c:v>
                </c:pt>
                <c:pt idx="16">
                  <c:v>0.489776951672862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A1-48C5-A3D1-132B75B1E715}"/>
            </c:ext>
          </c:extLst>
        </c:ser>
        <c:ser>
          <c:idx val="5"/>
          <c:order val="1"/>
          <c:tx>
            <c:v>Run 2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J$12:$J$2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Pyrosequencing!$N$12:$N$28</c:f>
              <c:numCache>
                <c:formatCode>#,##0.00</c:formatCode>
                <c:ptCount val="17"/>
                <c:pt idx="0">
                  <c:v>0.64628820960698696</c:v>
                </c:pt>
                <c:pt idx="1">
                  <c:v>0.72532751091703063</c:v>
                </c:pt>
                <c:pt idx="2">
                  <c:v>0.85414847161572049</c:v>
                </c:pt>
                <c:pt idx="3">
                  <c:v>0.47816593886462883</c:v>
                </c:pt>
                <c:pt idx="4">
                  <c:v>0.60611353711790406</c:v>
                </c:pt>
                <c:pt idx="5">
                  <c:v>0.52882096069869</c:v>
                </c:pt>
                <c:pt idx="6">
                  <c:v>0.80611353711790401</c:v>
                </c:pt>
                <c:pt idx="7">
                  <c:v>1.4091703056768561</c:v>
                </c:pt>
                <c:pt idx="8">
                  <c:v>0.52663755458515293</c:v>
                </c:pt>
                <c:pt idx="9">
                  <c:v>0.61659388646288205</c:v>
                </c:pt>
                <c:pt idx="10">
                  <c:v>0.6065502183406114</c:v>
                </c:pt>
                <c:pt idx="11">
                  <c:v>0.80262008733624457</c:v>
                </c:pt>
                <c:pt idx="12">
                  <c:v>1.0934497816593887</c:v>
                </c:pt>
                <c:pt idx="13">
                  <c:v>0.95414847161572069</c:v>
                </c:pt>
                <c:pt idx="14">
                  <c:v>0.83187772925764203</c:v>
                </c:pt>
                <c:pt idx="15">
                  <c:v>0.71266375545851535</c:v>
                </c:pt>
                <c:pt idx="16">
                  <c:v>0.764628820960698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A1-48C5-A3D1-132B75B1E715}"/>
            </c:ext>
          </c:extLst>
        </c:ser>
        <c:ser>
          <c:idx val="8"/>
          <c:order val="2"/>
          <c:tx>
            <c:v>Run 3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J$12:$J$2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Pyrosequencing!$P$12:$P$13</c:f>
              <c:numCache>
                <c:formatCode>#,##0.00</c:formatCode>
                <c:ptCount val="2"/>
                <c:pt idx="0">
                  <c:v>0.35555555555555557</c:v>
                </c:pt>
                <c:pt idx="1">
                  <c:v>0.397479954180985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FA1-48C5-A3D1-132B75B1E715}"/>
            </c:ext>
          </c:extLst>
        </c:ser>
        <c:ser>
          <c:idx val="11"/>
          <c:order val="3"/>
          <c:tx>
            <c:v>Run 4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marker>
          <c:xVal>
            <c:strRef>
              <c:f>Pyrosequencing!$J$12:$J$2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Pyrosequencing!$R$12:$R$13</c:f>
              <c:numCache>
                <c:formatCode>#,##0.00</c:formatCode>
                <c:ptCount val="2"/>
                <c:pt idx="0">
                  <c:v>0.49485926175627842</c:v>
                </c:pt>
                <c:pt idx="1">
                  <c:v>0.402831619753918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FA1-48C5-A3D1-132B75B1E7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2829872"/>
        <c:axId val="312832496"/>
      </c:scatterChart>
      <c:valAx>
        <c:axId val="312829872"/>
        <c:scaling>
          <c:orientation val="minMax"/>
          <c:max val="17.399999999999999"/>
          <c:min val="0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32496"/>
        <c:crosses val="autoZero"/>
        <c:crossBetween val="midCat"/>
        <c:majorUnit val="1"/>
        <c:minorUnit val="1"/>
      </c:valAx>
      <c:valAx>
        <c:axId val="312832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latin typeface="Arial" panose="020B0604020202020204" pitchFamily="34" charset="0"/>
                    <a:cs typeface="Arial" panose="020B0604020202020204" pitchFamily="34" charset="0"/>
                  </a:rPr>
                  <a:t>Control-adjusted Methylation vla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29872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100000">
          <a:schemeClr val="lt1">
            <a:lumMod val="95000"/>
          </a:schemeClr>
        </a:gs>
        <a:gs pos="43000">
          <a:schemeClr val="lt1"/>
        </a:gs>
      </a:gsLst>
      <a:path path="circle">
        <a:fillToRect l="50000" t="50000" r="50000" b="50000"/>
      </a:path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IC1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rgbClr val="00B050"/>
              </a:solidFill>
              <a:ln w="9525" cap="flat" cmpd="sng" algn="ctr">
                <a:noFill/>
                <a:round/>
              </a:ln>
              <a:effectLst/>
            </c:spPr>
          </c:marker>
          <c:xVal>
            <c:strRef>
              <c:f>'MS-MLPA'!$A$2:$A$1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'MS-MLPA'!$B$2:$B$18</c:f>
              <c:numCache>
                <c:formatCode>General</c:formatCode>
                <c:ptCount val="17"/>
                <c:pt idx="0">
                  <c:v>0.93</c:v>
                </c:pt>
                <c:pt idx="1">
                  <c:v>0.9</c:v>
                </c:pt>
                <c:pt idx="2">
                  <c:v>0.82</c:v>
                </c:pt>
                <c:pt idx="3">
                  <c:v>0.85</c:v>
                </c:pt>
                <c:pt idx="4">
                  <c:v>0.77</c:v>
                </c:pt>
                <c:pt idx="5">
                  <c:v>0.74</c:v>
                </c:pt>
                <c:pt idx="6">
                  <c:v>0.76</c:v>
                </c:pt>
                <c:pt idx="7">
                  <c:v>0.84</c:v>
                </c:pt>
                <c:pt idx="8">
                  <c:v>0.79</c:v>
                </c:pt>
                <c:pt idx="9">
                  <c:v>0.91</c:v>
                </c:pt>
                <c:pt idx="10">
                  <c:v>0.84</c:v>
                </c:pt>
                <c:pt idx="11">
                  <c:v>0.76</c:v>
                </c:pt>
                <c:pt idx="12">
                  <c:v>0.61</c:v>
                </c:pt>
                <c:pt idx="13">
                  <c:v>0.67</c:v>
                </c:pt>
                <c:pt idx="14">
                  <c:v>0.82</c:v>
                </c:pt>
                <c:pt idx="15">
                  <c:v>0.78</c:v>
                </c:pt>
                <c:pt idx="16">
                  <c:v>0.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BF9-49D5-AFF1-4FCD74A9D400}"/>
            </c:ext>
          </c:extLst>
        </c:ser>
        <c:ser>
          <c:idx val="5"/>
          <c:order val="1"/>
          <c:tx>
            <c:v>IC2</c:v>
          </c:tx>
          <c:spPr>
            <a:ln w="25400">
              <a:noFill/>
            </a:ln>
            <a:effectLst/>
          </c:spPr>
          <c:marker>
            <c:symbol val="circle"/>
            <c:size val="4"/>
            <c:spPr>
              <a:solidFill>
                <a:srgbClr val="00B0F0"/>
              </a:solidFill>
              <a:ln w="9525" cap="flat" cmpd="sng" algn="ctr">
                <a:noFill/>
                <a:round/>
              </a:ln>
              <a:effectLst/>
            </c:spPr>
          </c:marker>
          <c:xVal>
            <c:strRef>
              <c:f>'MS-MLPA'!$A$2:$A$18</c:f>
              <c:strCache>
                <c:ptCount val="17"/>
                <c:pt idx="0">
                  <c:v>M24412</c:v>
                </c:pt>
                <c:pt idx="1">
                  <c:v>M31540</c:v>
                </c:pt>
                <c:pt idx="2">
                  <c:v>M20439</c:v>
                </c:pt>
                <c:pt idx="3">
                  <c:v>M26662</c:v>
                </c:pt>
                <c:pt idx="4">
                  <c:v>M15248</c:v>
                </c:pt>
                <c:pt idx="5">
                  <c:v>M10281</c:v>
                </c:pt>
                <c:pt idx="6">
                  <c:v>M29105</c:v>
                </c:pt>
                <c:pt idx="7">
                  <c:v>M29234</c:v>
                </c:pt>
                <c:pt idx="8">
                  <c:v>M27284</c:v>
                </c:pt>
                <c:pt idx="9">
                  <c:v>M16159</c:v>
                </c:pt>
                <c:pt idx="10">
                  <c:v>M25591.2</c:v>
                </c:pt>
                <c:pt idx="11">
                  <c:v>M35702</c:v>
                </c:pt>
                <c:pt idx="12">
                  <c:v>M26037</c:v>
                </c:pt>
                <c:pt idx="13">
                  <c:v>M10767</c:v>
                </c:pt>
                <c:pt idx="14">
                  <c:v>M20439</c:v>
                </c:pt>
                <c:pt idx="15">
                  <c:v>M33489</c:v>
                </c:pt>
                <c:pt idx="16">
                  <c:v>M26912</c:v>
                </c:pt>
              </c:strCache>
            </c:strRef>
          </c:xVal>
          <c:yVal>
            <c:numRef>
              <c:f>'MS-MLPA'!$D$2:$D$18</c:f>
              <c:numCache>
                <c:formatCode>General</c:formatCode>
                <c:ptCount val="17"/>
                <c:pt idx="0">
                  <c:v>0.18</c:v>
                </c:pt>
                <c:pt idx="1">
                  <c:v>0.18</c:v>
                </c:pt>
                <c:pt idx="2">
                  <c:v>0.26</c:v>
                </c:pt>
                <c:pt idx="3">
                  <c:v>0.2</c:v>
                </c:pt>
                <c:pt idx="4">
                  <c:v>0.28999999999999998</c:v>
                </c:pt>
                <c:pt idx="5">
                  <c:v>0.28999999999999998</c:v>
                </c:pt>
                <c:pt idx="6">
                  <c:v>0.36</c:v>
                </c:pt>
                <c:pt idx="7">
                  <c:v>0.28999999999999998</c:v>
                </c:pt>
                <c:pt idx="8">
                  <c:v>0.26</c:v>
                </c:pt>
                <c:pt idx="9">
                  <c:v>0.2</c:v>
                </c:pt>
                <c:pt idx="10">
                  <c:v>0.14000000000000001</c:v>
                </c:pt>
                <c:pt idx="11">
                  <c:v>0.45</c:v>
                </c:pt>
                <c:pt idx="12">
                  <c:v>0.41</c:v>
                </c:pt>
                <c:pt idx="13">
                  <c:v>0.35</c:v>
                </c:pt>
                <c:pt idx="14">
                  <c:v>0.28000000000000003</c:v>
                </c:pt>
                <c:pt idx="15">
                  <c:v>0.31</c:v>
                </c:pt>
                <c:pt idx="16">
                  <c:v>0.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BF9-49D5-AFF1-4FCD74A9D4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2829872"/>
        <c:axId val="312832496"/>
      </c:scatterChart>
      <c:valAx>
        <c:axId val="312829872"/>
        <c:scaling>
          <c:orientation val="minMax"/>
          <c:max val="17.5"/>
          <c:min val="0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32496"/>
        <c:crosses val="autoZero"/>
        <c:crossBetween val="midCat"/>
        <c:majorUnit val="1"/>
        <c:minorUnit val="1"/>
      </c:valAx>
      <c:valAx>
        <c:axId val="312832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dk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latin typeface="Arial" panose="020B0604020202020204" pitchFamily="34" charset="0"/>
                    <a:cs typeface="Arial" panose="020B0604020202020204" pitchFamily="34" charset="0"/>
                  </a:rPr>
                  <a:t>Methlyation vla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dk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128298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50000"/>
                  <a:lumOff val="5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gradFill flip="none" rotWithShape="1">
      <a:gsLst>
        <a:gs pos="100000">
          <a:schemeClr val="lt1">
            <a:lumMod val="95000"/>
          </a:schemeClr>
        </a:gs>
        <a:gs pos="43000">
          <a:schemeClr val="lt1"/>
        </a:gs>
      </a:gsLst>
      <a:path path="circle">
        <a:fillToRect l="50000" t="50000" r="50000" b="50000"/>
      </a:path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acrossLinear" id="2">
  <a:schemeClr val="accent1"/>
  <a:schemeClr val="accent2"/>
  <a:schemeClr val="accent3"/>
  <a:schemeClr val="accent4"/>
  <a:schemeClr val="accent5"/>
  <a:schemeClr val="accent6"/>
</cs:colorStyle>
</file>

<file path=ppt/charts/colors2.xml><?xml version="1.0" encoding="utf-8"?>
<cs:colorStyle xmlns:cs="http://schemas.microsoft.com/office/drawing/2012/chartStyle" xmlns:a="http://schemas.openxmlformats.org/drawingml/2006/main" meth="acrossLinear" id="2">
  <a:schemeClr val="accent1"/>
  <a:schemeClr val="accent2"/>
  <a:schemeClr val="accent3"/>
  <a:schemeClr val="accent4"/>
  <a:schemeClr val="accent5"/>
  <a:schemeClr val="accent6"/>
</cs:colorStyle>
</file>

<file path=ppt/charts/colors3.xml><?xml version="1.0" encoding="utf-8"?>
<cs:colorStyle xmlns:cs="http://schemas.microsoft.com/office/drawing/2012/chartStyle" xmlns:a="http://schemas.openxmlformats.org/drawingml/2006/main" meth="acrossLinear" id="2">
  <a:schemeClr val="accent1"/>
  <a:schemeClr val="accent2"/>
  <a:schemeClr val="accent3"/>
  <a:schemeClr val="accent4"/>
  <a:schemeClr val="accent5"/>
  <a:schemeClr val="accent6"/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4">
  <cs:axisTitle>
    <cs:lnRef idx="0"/>
    <cs:fillRef idx="0"/>
    <cs:effectRef idx="0"/>
    <cs:fontRef idx="minor">
      <a:schemeClr val="dk1">
        <a:lumMod val="50000"/>
        <a:lumOff val="50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100000">
            <a:schemeClr val="lt1">
              <a:lumMod val="95000"/>
            </a:schemeClr>
          </a:gs>
          <a:gs pos="43000">
            <a:schemeClr val="lt1"/>
          </a:gs>
        </a:gsLst>
        <a:path path="circle">
          <a:fillToRect l="50000" t="50000" r="50000" b="50000"/>
        </a:path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>
        <a:solidFill>
          <a:schemeClr val="phClr">
            <a:alpha val="20000"/>
          </a:schemeClr>
        </a:solidFill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tx1"/>
    </cs:fontRef>
    <cs:spPr>
      <a:ln w="9525">
        <a:solidFill>
          <a:schemeClr val="dk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600" b="0" kern="1200" spc="70" baseline="0"/>
  </cs:title>
  <cs:trendline>
    <cs:lnRef idx="0">
      <cs:styleClr val="0"/>
    </cs:lnRef>
    <cs:fillRef idx="0"/>
    <cs:effectRef idx="0"/>
    <cs:fontRef idx="minor">
      <a:schemeClr val="tx1"/>
    </cs:fontRef>
    <cs:spPr>
      <a:ln w="63500" cap="rnd" cmpd="sng" algn="ctr">
        <a:solidFill>
          <a:schemeClr val="phClr">
            <a:alpha val="25000"/>
          </a:schemeClr>
        </a:solidFill>
        <a:round/>
      </a:ln>
    </cs:spPr>
  </cs:trendline>
  <cs:trendline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dk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4">
  <cs:axisTitle>
    <cs:lnRef idx="0"/>
    <cs:fillRef idx="0"/>
    <cs:effectRef idx="0"/>
    <cs:fontRef idx="minor">
      <a:schemeClr val="dk1">
        <a:lumMod val="50000"/>
        <a:lumOff val="50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100000">
            <a:schemeClr val="lt1">
              <a:lumMod val="95000"/>
            </a:schemeClr>
          </a:gs>
          <a:gs pos="43000">
            <a:schemeClr val="lt1"/>
          </a:gs>
        </a:gsLst>
        <a:path path="circle">
          <a:fillToRect l="50000" t="50000" r="50000" b="50000"/>
        </a:path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>
        <a:solidFill>
          <a:schemeClr val="phClr">
            <a:alpha val="20000"/>
          </a:schemeClr>
        </a:solidFill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tx1"/>
    </cs:fontRef>
    <cs:spPr>
      <a:ln w="9525">
        <a:solidFill>
          <a:schemeClr val="dk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600" b="0" kern="1200" spc="70" baseline="0"/>
  </cs:title>
  <cs:trendline>
    <cs:lnRef idx="0">
      <cs:styleClr val="0"/>
    </cs:lnRef>
    <cs:fillRef idx="0"/>
    <cs:effectRef idx="0"/>
    <cs:fontRef idx="minor">
      <a:schemeClr val="tx1"/>
    </cs:fontRef>
    <cs:spPr>
      <a:ln w="63500" cap="rnd" cmpd="sng" algn="ctr">
        <a:solidFill>
          <a:schemeClr val="phClr">
            <a:alpha val="25000"/>
          </a:schemeClr>
        </a:solidFill>
        <a:round/>
      </a:ln>
    </cs:spPr>
  </cs:trendline>
  <cs:trendline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dk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44">
  <cs:axisTitle>
    <cs:lnRef idx="0"/>
    <cs:fillRef idx="0"/>
    <cs:effectRef idx="0"/>
    <cs:fontRef idx="minor">
      <a:schemeClr val="dk1">
        <a:lumMod val="50000"/>
        <a:lumOff val="50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100000">
            <a:schemeClr val="lt1">
              <a:lumMod val="95000"/>
            </a:schemeClr>
          </a:gs>
          <a:gs pos="43000">
            <a:schemeClr val="lt1"/>
          </a:gs>
        </a:gsLst>
        <a:path path="circle">
          <a:fillToRect l="50000" t="50000" r="50000" b="50000"/>
        </a:path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>
        <a:solidFill>
          <a:schemeClr val="phClr">
            <a:alpha val="20000"/>
          </a:schemeClr>
        </a:solidFill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tx1"/>
    </cs:fontRef>
    <cs:spPr>
      <a:ln w="9525">
        <a:solidFill>
          <a:schemeClr val="dk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600" b="0" kern="1200" spc="70" baseline="0"/>
  </cs:title>
  <cs:trendline>
    <cs:lnRef idx="0">
      <cs:styleClr val="0"/>
    </cs:lnRef>
    <cs:fillRef idx="0"/>
    <cs:effectRef idx="0"/>
    <cs:fontRef idx="minor">
      <a:schemeClr val="tx1"/>
    </cs:fontRef>
    <cs:spPr>
      <a:ln w="63500" cap="rnd" cmpd="sng" algn="ctr">
        <a:solidFill>
          <a:schemeClr val="phClr">
            <a:alpha val="25000"/>
          </a:schemeClr>
        </a:solidFill>
        <a:round/>
      </a:ln>
    </cs:spPr>
  </cs:trendline>
  <cs:trendline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dk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44">
  <cs:axisTitle>
    <cs:lnRef idx="0"/>
    <cs:fillRef idx="0"/>
    <cs:effectRef idx="0"/>
    <cs:fontRef idx="minor">
      <a:schemeClr val="dk1">
        <a:lumMod val="50000"/>
        <a:lumOff val="50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100000">
            <a:schemeClr val="lt1">
              <a:lumMod val="95000"/>
            </a:schemeClr>
          </a:gs>
          <a:gs pos="43000">
            <a:schemeClr val="lt1"/>
          </a:gs>
        </a:gsLst>
        <a:path path="circle">
          <a:fillToRect l="50000" t="50000" r="50000" b="50000"/>
        </a:path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>
        <a:solidFill>
          <a:schemeClr val="phClr">
            <a:alpha val="20000"/>
          </a:schemeClr>
        </a:solidFill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tx1"/>
    </cs:fontRef>
    <cs:spPr>
      <a:ln w="9525">
        <a:solidFill>
          <a:schemeClr val="dk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600" b="0" kern="1200" spc="70" baseline="0"/>
  </cs:title>
  <cs:trendline>
    <cs:lnRef idx="0">
      <cs:styleClr val="0"/>
    </cs:lnRef>
    <cs:fillRef idx="0"/>
    <cs:effectRef idx="0"/>
    <cs:fontRef idx="minor">
      <a:schemeClr val="tx1"/>
    </cs:fontRef>
    <cs:spPr>
      <a:ln w="63500" cap="rnd" cmpd="sng" algn="ctr">
        <a:solidFill>
          <a:schemeClr val="phClr">
            <a:alpha val="25000"/>
          </a:schemeClr>
        </a:solidFill>
        <a:round/>
      </a:ln>
    </cs:spPr>
  </cs:trendline>
  <cs:trendline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dk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44">
  <cs:axisTitle>
    <cs:lnRef idx="0"/>
    <cs:fillRef idx="0"/>
    <cs:effectRef idx="0"/>
    <cs:fontRef idx="minor">
      <a:schemeClr val="dk1">
        <a:lumMod val="50000"/>
        <a:lumOff val="50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100000">
            <a:schemeClr val="lt1">
              <a:lumMod val="95000"/>
            </a:schemeClr>
          </a:gs>
          <a:gs pos="43000">
            <a:schemeClr val="lt1"/>
          </a:gs>
        </a:gsLst>
        <a:path path="circle">
          <a:fillToRect l="50000" t="50000" r="50000" b="50000"/>
        </a:path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>
        <a:solidFill>
          <a:schemeClr val="phClr">
            <a:alpha val="20000"/>
          </a:schemeClr>
        </a:solidFill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50000"/>
        <a:lumOff val="50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tx1"/>
    </cs:fontRef>
    <cs:spPr>
      <a:ln w="9525">
        <a:solidFill>
          <a:schemeClr val="dk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>
        <a:solidFill>
          <a:schemeClr val="dk1">
            <a:lumMod val="35000"/>
            <a:lumOff val="65000"/>
          </a:schemeClr>
        </a:solidFill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600" b="0" kern="1200" spc="70" baseline="0"/>
  </cs:title>
  <cs:trendline>
    <cs:lnRef idx="0">
      <cs:styleClr val="0"/>
    </cs:lnRef>
    <cs:fillRef idx="0"/>
    <cs:effectRef idx="0"/>
    <cs:fontRef idx="minor">
      <a:schemeClr val="tx1"/>
    </cs:fontRef>
    <cs:spPr>
      <a:ln w="63500" cap="rnd" cmpd="sng" algn="ctr">
        <a:solidFill>
          <a:schemeClr val="phClr">
            <a:alpha val="25000"/>
          </a:schemeClr>
        </a:solidFill>
        <a:round/>
      </a:ln>
    </cs:spPr>
  </cs:trendline>
  <cs:trendlineLabel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dk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dk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781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986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250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7484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526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9571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8551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8607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039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3993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0802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78941-DDB8-4049-BA7C-78B722027E2A}" type="datetimeFigureOut">
              <a:rPr lang="de-DE" smtClean="0"/>
              <a:t>16.06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19784-69B8-4AB9-8163-6143D13D16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9544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7301F447-EEF7-48F5-AF73-7566EE7F64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1248" y="334644"/>
            <a:ext cx="10509504" cy="1076914"/>
          </a:xfrm>
        </p:spPr>
        <p:txBody>
          <a:bodyPr anchor="ctr">
            <a:normAutofit/>
          </a:bodyPr>
          <a:lstStyle/>
          <a:p>
            <a:r>
              <a:rPr lang="de-DE" sz="4000">
                <a:latin typeface="Arial" panose="020B0604020202020204" pitchFamily="34" charset="0"/>
                <a:cs typeface="Arial" panose="020B0604020202020204" pitchFamily="34" charset="0"/>
              </a:rPr>
              <a:t>1 a) IC1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7117410-A2A4-4085-9ADC-46744551DB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2772" y="0"/>
            <a:ext cx="10506456" cy="191386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9F74EB5-E547-4FB4-95F5-BCC788F3C4A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1248" y="1512994"/>
            <a:ext cx="10506456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Inhaltsplatzhalter 5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10978881"/>
              </p:ext>
            </p:extLst>
          </p:nvPr>
        </p:nvGraphicFramePr>
        <p:xfrm>
          <a:off x="838200" y="1737360"/>
          <a:ext cx="10506456" cy="4535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76757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7301F447-EEF7-48F5-AF73-7566EE7F64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1248" y="334644"/>
            <a:ext cx="10509504" cy="1076914"/>
          </a:xfrm>
        </p:spPr>
        <p:txBody>
          <a:bodyPr anchor="ctr">
            <a:normAutofit/>
          </a:bodyPr>
          <a:lstStyle/>
          <a:p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1 b) IC2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7117410-A2A4-4085-9ADC-46744551DB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2772" y="0"/>
            <a:ext cx="10506456" cy="191386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9F74EB5-E547-4FB4-95F5-BCC788F3C4A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1248" y="1512994"/>
            <a:ext cx="10506456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5" name="Inhaltsplatzhalter 4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64147302"/>
              </p:ext>
            </p:extLst>
          </p:nvPr>
        </p:nvGraphicFramePr>
        <p:xfrm>
          <a:off x="838200" y="1737360"/>
          <a:ext cx="10506456" cy="4535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55764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8" name="Rectangle 9">
            <a:extLst>
              <a:ext uri="{FF2B5EF4-FFF2-40B4-BE49-F238E27FC236}">
                <a16:creationId xmlns:a16="http://schemas.microsoft.com/office/drawing/2014/main" id="{7301F447-EEF7-48F5-AF73-7566EE7F64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1248" y="334644"/>
            <a:ext cx="10509504" cy="1076914"/>
          </a:xfrm>
        </p:spPr>
        <p:txBody>
          <a:bodyPr anchor="ctr">
            <a:normAutofit/>
          </a:bodyPr>
          <a:lstStyle/>
          <a:p>
            <a:r>
              <a:rPr lang="de-DE" sz="4000"/>
              <a:t>2</a:t>
            </a:r>
          </a:p>
        </p:txBody>
      </p:sp>
      <p:sp>
        <p:nvSpPr>
          <p:cNvPr id="19" name="Rectangle 11">
            <a:extLst>
              <a:ext uri="{FF2B5EF4-FFF2-40B4-BE49-F238E27FC236}">
                <a16:creationId xmlns:a16="http://schemas.microsoft.com/office/drawing/2014/main" id="{F7117410-A2A4-4085-9ADC-46744551DB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2772" y="0"/>
            <a:ext cx="10506456" cy="191386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0" name="Rectangle 13">
            <a:extLst>
              <a:ext uri="{FF2B5EF4-FFF2-40B4-BE49-F238E27FC236}">
                <a16:creationId xmlns:a16="http://schemas.microsoft.com/office/drawing/2014/main" id="{99F74EB5-E547-4FB4-95F5-BCC788F3C4A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41248" y="1512994"/>
            <a:ext cx="10506456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5" name="Inhaltsplatzhalter 4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9309987"/>
              </p:ext>
            </p:extLst>
          </p:nvPr>
        </p:nvGraphicFramePr>
        <p:xfrm>
          <a:off x="838200" y="1737360"/>
          <a:ext cx="10506456" cy="4535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46981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3200" dirty="0">
                <a:latin typeface="Arial" panose="020B0604020202020204" pitchFamily="34" charset="0"/>
                <a:cs typeface="Arial" panose="020B0604020202020204" pitchFamily="34" charset="0"/>
              </a:rPr>
              <a:t>3 a) IC1</a:t>
            </a:r>
          </a:p>
        </p:txBody>
      </p:sp>
      <p:graphicFrame>
        <p:nvGraphicFramePr>
          <p:cNvPr id="4" name="Inhaltsplatzhalt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77900812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Eckige Klammer links 4" title="UPD(11)pat"/>
          <p:cNvSpPr/>
          <p:nvPr/>
        </p:nvSpPr>
        <p:spPr>
          <a:xfrm rot="16200000">
            <a:off x="5711827" y="1571624"/>
            <a:ext cx="139701" cy="8731252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lIns="0" rIns="504000" rtlCol="0" anchor="b" anchorCtr="1"/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UPD(11)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Eckige Klammer links 5" title="UPD(11)pat"/>
          <p:cNvSpPr/>
          <p:nvPr/>
        </p:nvSpPr>
        <p:spPr>
          <a:xfrm rot="16200000">
            <a:off x="10624198" y="5390506"/>
            <a:ext cx="139702" cy="109348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lIns="0" rIns="504000" rtlCol="0" anchor="b" anchorCtr="1"/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IC1 LOM</a:t>
            </a:r>
          </a:p>
        </p:txBody>
      </p:sp>
    </p:spTree>
    <p:extLst>
      <p:ext uri="{BB962C8B-B14F-4D97-AF65-F5344CB8AC3E}">
        <p14:creationId xmlns:p14="http://schemas.microsoft.com/office/powerpoint/2010/main" val="3302954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3200" dirty="0">
                <a:latin typeface="Arial" panose="020B0604020202020204" pitchFamily="34" charset="0"/>
                <a:cs typeface="Arial" panose="020B0604020202020204" pitchFamily="34" charset="0"/>
              </a:rPr>
              <a:t>3 b) IC2</a:t>
            </a:r>
          </a:p>
        </p:txBody>
      </p:sp>
      <p:graphicFrame>
        <p:nvGraphicFramePr>
          <p:cNvPr id="4" name="Inhaltsplatzhalt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94163667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Eckige Klammer links 4" title="UPD(11)pat"/>
          <p:cNvSpPr/>
          <p:nvPr/>
        </p:nvSpPr>
        <p:spPr>
          <a:xfrm rot="16200000">
            <a:off x="6130018" y="975633"/>
            <a:ext cx="319315" cy="974724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lIns="0" rIns="792000" rtlCol="0" anchor="b" anchorCtr="1"/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UPD(11)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744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3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graphicFrame>
        <p:nvGraphicFramePr>
          <p:cNvPr id="8" name="Inhaltsplatzhalter 7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17028409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Eckige Klammer links 4" title="UPD(11)pat"/>
          <p:cNvSpPr/>
          <p:nvPr/>
        </p:nvSpPr>
        <p:spPr>
          <a:xfrm rot="16200000">
            <a:off x="6113428" y="1185827"/>
            <a:ext cx="482600" cy="9363143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vert="vert" lIns="0" rIns="1188000" rtlCol="0" anchor="b" anchorCtr="1"/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UPD(11)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8424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47</Words>
  <Application>Microsoft Office PowerPoint</Application>
  <PresentationFormat>Breitbild</PresentationFormat>
  <Paragraphs>1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1 a) IC1</vt:lpstr>
      <vt:lpstr>1 b) IC2</vt:lpstr>
      <vt:lpstr>2</vt:lpstr>
      <vt:lpstr>3 a) IC1</vt:lpstr>
      <vt:lpstr>3 b) IC2</vt:lpstr>
      <vt:lpstr>4</vt:lpstr>
    </vt:vector>
  </TitlesOfParts>
  <Company>Universitätsklinikum Aachen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</dc:title>
  <dc:creator>Schlaich, Elia</dc:creator>
  <cp:lastModifiedBy>Eggermann, Thomas</cp:lastModifiedBy>
  <cp:revision>19</cp:revision>
  <dcterms:created xsi:type="dcterms:W3CDTF">2023-03-07T11:49:34Z</dcterms:created>
  <dcterms:modified xsi:type="dcterms:W3CDTF">2023-06-16T05:55:59Z</dcterms:modified>
</cp:coreProperties>
</file>